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1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800EE-356F-703A-6E98-7F9B51257E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7B7A9C-75E3-3766-355C-50BFCA8E3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2C0C3-C865-D08E-9315-59ABFE44A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A8D42E-93DC-334C-CF2D-737D13412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FDF33-B969-1FC7-D676-F9AC007A4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601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75D07-C5B4-6CDA-AF09-B7B620EA71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F1BADA-3DCF-CF8F-1199-DD459D5C8F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1BFB9B-47EE-5DE5-0E1A-96CF17819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1D55D-B268-3DF2-5A97-ADB4CE5F1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C853B-8326-2FEB-9C40-E08E70440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50230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9C8C41-3B7A-4B31-6D59-9621E846F7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C971E6-6847-EBD0-BCE9-C5DBAAF103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26422-19EE-E81F-7116-56D2069AF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14EC2-8A71-D6B3-16AC-8017BB0DF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49E1A2-C699-D3D7-53CF-5218321F2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097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2A3D5-AE3A-5AF8-20F7-8462CA1E76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8453A9-9881-A454-C31A-2C1A60191B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9817D-B352-3D54-8A4B-52D106274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428981-C160-BD60-A1A6-3929DC6ED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882D2-7284-E13A-8302-49702D623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98776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A399E-B71C-EAC8-7F54-AC4E7F7C09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91AA55-CC4C-E37F-5AB7-408E6A3D80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97ECD-B0E4-9BA3-5DC7-4B9D1584D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E13FC4-F846-894B-2458-00B1C0801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2F278-4412-F18D-D31F-E98284758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58765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C61C8-4B73-0B3A-2056-9881E2634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F3867A-9957-71EA-3BCC-E4D98C8C9A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48F9CB-1E9A-3ED2-561B-4D14C3D6ED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D1C579-7F0C-59FF-2ACB-F10BA3183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3ABA16-ACE7-DC57-43A6-C059B50E8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ACEEBD-00E1-D1B1-E405-06E58C58B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6897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43C99E-08F0-852A-066A-60D29A5A9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AE93F2-6B40-823A-177E-5F6DC31BE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ABC142-CED0-B298-774C-8832F3FC13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4FD5A72-6FC4-B51C-8D9E-705A78AF3E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F13A9E-9934-63D8-BFB8-93292C9AC7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A55947-8C9D-AEDE-D058-B7C07019E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0B3C03-88E3-4984-80F0-17C4952CB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754EA8-BC37-8174-8AC5-B5A950B65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8542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12E177-6BC7-17B3-D129-7BE309EDA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81169A-F2CA-F3C4-48C6-AC90B7C38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57DFBD-EFE2-5254-06D0-644F1770F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00A8F6-A622-F032-71D7-9AB6B20D4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8901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8911E1-D3AB-0EF9-CAA4-F86629286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5FDEE9-D79A-E50D-F73C-0EF582481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FAE346-5F13-B289-CC7E-E4F1BA43B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7282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AFC9F-8EBD-9E5C-2BBF-8FBF58F980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2526A0-0218-6E57-6017-77A1361F7C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D38777-0323-05CA-ADFC-552BCBFB40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D30917-4FE3-0CBE-137B-C37CDCE6F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03D77-B513-5EE6-28E1-E9943FFE7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1FEA3C-7C71-DE84-9EA2-C8C50F112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00822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07775-14CB-5826-5382-71259F00B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CDC05D-EAF7-8F85-9AD5-FB723D271D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B19E0D-568E-0468-A0B1-91652314B1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4E7E2C-60B7-9A49-20AA-79DBC2F7A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A60477-17DA-DE5E-58AB-F9D45369D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2225C2-BC11-552E-023E-2E1F0B329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94707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809782-74E2-178A-1CC3-C1DECE1A0C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DF49E3-B828-2032-EBEB-B8896BD5E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BDB8E-6DF8-D4BE-A185-159437321F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53835E-CEA1-DD79-F347-DF2935AE26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16B69A-21BE-E065-37EF-ABB08FF0F5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84800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B6321FA9-8667-766D-87FB-F06CEC4697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/>
        </p:blipFill>
        <p:spPr bwMode="auto">
          <a:xfrm>
            <a:off x="4039176" y="2945699"/>
            <a:ext cx="4113648" cy="2847911"/>
          </a:xfrm>
          <a:prstGeom prst="rect">
            <a:avLst/>
          </a:prstGeom>
        </p:spPr>
      </p:pic>
      <p:sp>
        <p:nvSpPr>
          <p:cNvPr id="4" name="TextBox 11">
            <a:extLst>
              <a:ext uri="{FF2B5EF4-FFF2-40B4-BE49-F238E27FC236}">
                <a16:creationId xmlns:a16="http://schemas.microsoft.com/office/drawing/2014/main" id="{4555A8AB-4711-8C87-BF0A-586C8B33E92D}"/>
              </a:ext>
            </a:extLst>
          </p:cNvPr>
          <p:cNvSpPr txBox="1"/>
          <p:nvPr/>
        </p:nvSpPr>
        <p:spPr bwMode="auto">
          <a:xfrm>
            <a:off x="280442" y="29757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600" b="1" dirty="0">
                <a:latin typeface="Arial"/>
                <a:cs typeface="Arial"/>
              </a:rPr>
              <a:t>Figure 6D</a:t>
            </a:r>
            <a:endParaRPr sz="1600" b="1" dirty="0">
              <a:latin typeface="Arial"/>
              <a:cs typeface="Arial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E6C1254-0056-4FB3-FF81-CE67B16E48DD}"/>
              </a:ext>
            </a:extLst>
          </p:cNvPr>
          <p:cNvSpPr/>
          <p:nvPr/>
        </p:nvSpPr>
        <p:spPr>
          <a:xfrm>
            <a:off x="4499287" y="3216264"/>
            <a:ext cx="1572585" cy="3449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5" name="TextBox 11">
            <a:extLst>
              <a:ext uri="{FF2B5EF4-FFF2-40B4-BE49-F238E27FC236}">
                <a16:creationId xmlns:a16="http://schemas.microsoft.com/office/drawing/2014/main" id="{A70DF59F-2A8D-5D12-B6A7-0D5E4C4D1170}"/>
              </a:ext>
            </a:extLst>
          </p:cNvPr>
          <p:cNvSpPr txBox="1"/>
          <p:nvPr/>
        </p:nvSpPr>
        <p:spPr bwMode="auto">
          <a:xfrm>
            <a:off x="8163955" y="3234864"/>
            <a:ext cx="809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400" dirty="0">
                <a:solidFill>
                  <a:srgbClr val="FF0000"/>
                </a:solidFill>
                <a:latin typeface="Arial"/>
                <a:cs typeface="Arial"/>
              </a:rPr>
              <a:t>Vinculin</a:t>
            </a:r>
            <a:endParaRPr sz="4000" dirty="0">
              <a:solidFill>
                <a:srgbClr val="FF0000"/>
              </a:solidFill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EAF104F-6890-7CA2-1060-B85015124E61}"/>
              </a:ext>
            </a:extLst>
          </p:cNvPr>
          <p:cNvCxnSpPr/>
          <p:nvPr/>
        </p:nvCxnSpPr>
        <p:spPr>
          <a:xfrm>
            <a:off x="4127967" y="4075208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DB54A292-94F0-4C71-F4B9-1F9294E93BEE}"/>
              </a:ext>
            </a:extLst>
          </p:cNvPr>
          <p:cNvCxnSpPr/>
          <p:nvPr/>
        </p:nvCxnSpPr>
        <p:spPr>
          <a:xfrm>
            <a:off x="4127968" y="3687582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FCF929EE-0908-8D11-6B38-D533726F1E88}"/>
              </a:ext>
            </a:extLst>
          </p:cNvPr>
          <p:cNvCxnSpPr/>
          <p:nvPr/>
        </p:nvCxnSpPr>
        <p:spPr>
          <a:xfrm>
            <a:off x="4127968" y="4483891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F9D9FEA-13AA-A5D7-64FE-05E3FD0366D1}"/>
              </a:ext>
            </a:extLst>
          </p:cNvPr>
          <p:cNvCxnSpPr/>
          <p:nvPr/>
        </p:nvCxnSpPr>
        <p:spPr>
          <a:xfrm>
            <a:off x="4127968" y="5105561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A53F0E23-A591-37CD-FE2E-2B60D21CD2CA}"/>
              </a:ext>
            </a:extLst>
          </p:cNvPr>
          <p:cNvSpPr txBox="1"/>
          <p:nvPr/>
        </p:nvSpPr>
        <p:spPr>
          <a:xfrm>
            <a:off x="3731625" y="353369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CFA4568-0B7F-CBB6-A48F-5301B8AB022E}"/>
              </a:ext>
            </a:extLst>
          </p:cNvPr>
          <p:cNvSpPr txBox="1"/>
          <p:nvPr/>
        </p:nvSpPr>
        <p:spPr>
          <a:xfrm>
            <a:off x="3731625" y="392131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4EB6E16-50E0-0B44-3FD3-0FC13CD13FD9}"/>
              </a:ext>
            </a:extLst>
          </p:cNvPr>
          <p:cNvSpPr txBox="1"/>
          <p:nvPr/>
        </p:nvSpPr>
        <p:spPr>
          <a:xfrm>
            <a:off x="3711638" y="433000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369B465-0FD5-3952-5884-1541605FED8C}"/>
              </a:ext>
            </a:extLst>
          </p:cNvPr>
          <p:cNvSpPr txBox="1"/>
          <p:nvPr/>
        </p:nvSpPr>
        <p:spPr>
          <a:xfrm>
            <a:off x="3728084" y="495167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BFAF063-57FE-7C7C-0E22-F0D3DCD3A603}"/>
              </a:ext>
            </a:extLst>
          </p:cNvPr>
          <p:cNvSpPr txBox="1"/>
          <p:nvPr/>
        </p:nvSpPr>
        <p:spPr>
          <a:xfrm>
            <a:off x="3482248" y="536858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CAB68970-7D6C-9D67-EE46-25259827A55E}"/>
              </a:ext>
            </a:extLst>
          </p:cNvPr>
          <p:cNvCxnSpPr/>
          <p:nvPr/>
        </p:nvCxnSpPr>
        <p:spPr>
          <a:xfrm>
            <a:off x="4127967" y="3468921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AE120F5-7342-1541-3208-65A365A6BE51}"/>
              </a:ext>
            </a:extLst>
          </p:cNvPr>
          <p:cNvCxnSpPr/>
          <p:nvPr/>
        </p:nvCxnSpPr>
        <p:spPr>
          <a:xfrm>
            <a:off x="4127967" y="3237314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CE0F9AA0-6FCB-01EB-1D47-3E1E526C802D}"/>
              </a:ext>
            </a:extLst>
          </p:cNvPr>
          <p:cNvSpPr txBox="1"/>
          <p:nvPr/>
        </p:nvSpPr>
        <p:spPr>
          <a:xfrm>
            <a:off x="3647349" y="3315032"/>
            <a:ext cx="469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8A9D2E5-C8B8-2805-FA3A-6F3B99838058}"/>
              </a:ext>
            </a:extLst>
          </p:cNvPr>
          <p:cNvSpPr txBox="1"/>
          <p:nvPr/>
        </p:nvSpPr>
        <p:spPr>
          <a:xfrm>
            <a:off x="3658480" y="308989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55AAAF9-720E-ED82-23FD-750E9B7B8A36}"/>
              </a:ext>
            </a:extLst>
          </p:cNvPr>
          <p:cNvSpPr txBox="1"/>
          <p:nvPr/>
        </p:nvSpPr>
        <p:spPr>
          <a:xfrm>
            <a:off x="5002727" y="506484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J2 IP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8F640E0-7EC3-0C38-331A-F4447362604B}"/>
              </a:ext>
            </a:extLst>
          </p:cNvPr>
          <p:cNvSpPr txBox="1"/>
          <p:nvPr/>
        </p:nvSpPr>
        <p:spPr>
          <a:xfrm rot="16200000">
            <a:off x="5671387" y="262002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6A721FE-FAF9-1D79-8843-5D4B350D3EE4}"/>
              </a:ext>
            </a:extLst>
          </p:cNvPr>
          <p:cNvCxnSpPr>
            <a:cxnSpLocks/>
          </p:cNvCxnSpPr>
          <p:nvPr/>
        </p:nvCxnSpPr>
        <p:spPr>
          <a:xfrm flipV="1">
            <a:off x="4522090" y="751076"/>
            <a:ext cx="1482722" cy="2214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14B355B9-41CC-5A0C-7713-E8A838FB06DB}"/>
              </a:ext>
            </a:extLst>
          </p:cNvPr>
          <p:cNvSpPr txBox="1"/>
          <p:nvPr/>
        </p:nvSpPr>
        <p:spPr>
          <a:xfrm>
            <a:off x="6695303" y="46685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D9EC669-7DE5-2B33-C197-C82D16B57B78}"/>
              </a:ext>
            </a:extLst>
          </p:cNvPr>
          <p:cNvSpPr txBox="1"/>
          <p:nvPr/>
        </p:nvSpPr>
        <p:spPr>
          <a:xfrm rot="16200000">
            <a:off x="4143901" y="2341056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24DBCA9-5029-D058-CFDD-B33E2C18E994}"/>
              </a:ext>
            </a:extLst>
          </p:cNvPr>
          <p:cNvSpPr txBox="1"/>
          <p:nvPr/>
        </p:nvSpPr>
        <p:spPr>
          <a:xfrm rot="16200000">
            <a:off x="4249224" y="2182170"/>
            <a:ext cx="1295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L-NG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602C6F5-A6F3-DAEA-8B91-BAEA011F6640}"/>
              </a:ext>
            </a:extLst>
          </p:cNvPr>
          <p:cNvSpPr txBox="1"/>
          <p:nvPr/>
        </p:nvSpPr>
        <p:spPr>
          <a:xfrm rot="16200000">
            <a:off x="4683691" y="2352890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E092371-4573-2413-1595-383F0AD9147D}"/>
              </a:ext>
            </a:extLst>
          </p:cNvPr>
          <p:cNvSpPr txBox="1"/>
          <p:nvPr/>
        </p:nvSpPr>
        <p:spPr>
          <a:xfrm rot="16200000">
            <a:off x="4778147" y="2190561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72730D9-CC52-F47B-3280-DEF330E3A39F}"/>
              </a:ext>
            </a:extLst>
          </p:cNvPr>
          <p:cNvSpPr txBox="1"/>
          <p:nvPr/>
        </p:nvSpPr>
        <p:spPr>
          <a:xfrm rot="16200000">
            <a:off x="4553305" y="1751016"/>
            <a:ext cx="21578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2D12D96F-7A19-1EBA-E7D5-340BCD5B7101}"/>
              </a:ext>
            </a:extLst>
          </p:cNvPr>
          <p:cNvCxnSpPr>
            <a:cxnSpLocks/>
          </p:cNvCxnSpPr>
          <p:nvPr/>
        </p:nvCxnSpPr>
        <p:spPr>
          <a:xfrm flipV="1">
            <a:off x="6272203" y="728928"/>
            <a:ext cx="1482722" cy="2214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102DE628-176D-A874-378A-6C4468CAEB8F}"/>
              </a:ext>
            </a:extLst>
          </p:cNvPr>
          <p:cNvSpPr txBox="1"/>
          <p:nvPr/>
        </p:nvSpPr>
        <p:spPr>
          <a:xfrm rot="16200000">
            <a:off x="7433799" y="258505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3C323F7-D40C-CF72-3E9C-F54BD3A53B1D}"/>
              </a:ext>
            </a:extLst>
          </p:cNvPr>
          <p:cNvSpPr txBox="1"/>
          <p:nvPr/>
        </p:nvSpPr>
        <p:spPr>
          <a:xfrm rot="16200000">
            <a:off x="5906313" y="2306087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A422D5B-BC79-047C-E5AD-DAE3912175B5}"/>
              </a:ext>
            </a:extLst>
          </p:cNvPr>
          <p:cNvSpPr txBox="1"/>
          <p:nvPr/>
        </p:nvSpPr>
        <p:spPr>
          <a:xfrm rot="16200000">
            <a:off x="6011636" y="2147201"/>
            <a:ext cx="1295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L-NG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9BA81DC-4DDD-C3C0-9A6A-0FF15CC39298}"/>
              </a:ext>
            </a:extLst>
          </p:cNvPr>
          <p:cNvSpPr txBox="1"/>
          <p:nvPr/>
        </p:nvSpPr>
        <p:spPr>
          <a:xfrm rot="16200000">
            <a:off x="6446103" y="2317921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88BFE5A-B303-E1C9-AA51-2DE6DE0CB964}"/>
              </a:ext>
            </a:extLst>
          </p:cNvPr>
          <p:cNvSpPr txBox="1"/>
          <p:nvPr/>
        </p:nvSpPr>
        <p:spPr>
          <a:xfrm rot="16200000">
            <a:off x="6540559" y="2155592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a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2F65750-CA59-D922-B45B-51A728964CB9}"/>
              </a:ext>
            </a:extLst>
          </p:cNvPr>
          <p:cNvSpPr txBox="1"/>
          <p:nvPr/>
        </p:nvSpPr>
        <p:spPr>
          <a:xfrm rot="16200000">
            <a:off x="6320754" y="1722160"/>
            <a:ext cx="21578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4227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 Carvalho Schäfer</dc:creator>
  <cp:lastModifiedBy>Yasmin Carvalho Schäfer</cp:lastModifiedBy>
  <cp:revision>8</cp:revision>
  <dcterms:created xsi:type="dcterms:W3CDTF">2024-06-28T19:09:49Z</dcterms:created>
  <dcterms:modified xsi:type="dcterms:W3CDTF">2024-08-13T12:00:26Z</dcterms:modified>
</cp:coreProperties>
</file>